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notesMasterIdLst>
    <p:notesMasterId r:id="rId6"/>
  </p:notesMasterIdLst>
  <p:sldIdLst>
    <p:sldId id="25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14CB68D-C47D-A99A-0993-7C420C81DD4D}" v="10" dt="2024-04-11T17:46:27.585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511"/>
    <p:restoredTop sz="77211"/>
  </p:normalViewPr>
  <p:slideViewPr>
    <p:cSldViewPr snapToGrid="0">
      <p:cViewPr varScale="1">
        <p:scale>
          <a:sx n="57" d="100"/>
          <a:sy n="57" d="100"/>
        </p:scale>
        <p:origin x="132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atta, Dibyadyuti" userId="S::ddatta@iu.edu::e9b7952f-db9c-443c-88f8-1fcb0dc37d8c" providerId="AD" clId="Web-{014CB68D-C47D-A99A-0993-7C420C81DD4D}"/>
    <pc:docChg chg="modSld">
      <pc:chgData name="Datta, Dibyadyuti" userId="S::ddatta@iu.edu::e9b7952f-db9c-443c-88f8-1fcb0dc37d8c" providerId="AD" clId="Web-{014CB68D-C47D-A99A-0993-7C420C81DD4D}" dt="2024-04-11T17:46:27.585" v="4" actId="1076"/>
      <pc:docMkLst>
        <pc:docMk/>
      </pc:docMkLst>
      <pc:sldChg chg="modSp">
        <pc:chgData name="Datta, Dibyadyuti" userId="S::ddatta@iu.edu::e9b7952f-db9c-443c-88f8-1fcb0dc37d8c" providerId="AD" clId="Web-{014CB68D-C47D-A99A-0993-7C420C81DD4D}" dt="2024-04-11T17:46:27.585" v="4" actId="1076"/>
        <pc:sldMkLst>
          <pc:docMk/>
          <pc:sldMk cId="1962860318" sldId="256"/>
        </pc:sldMkLst>
        <pc:spChg chg="mod">
          <ac:chgData name="Datta, Dibyadyuti" userId="S::ddatta@iu.edu::e9b7952f-db9c-443c-88f8-1fcb0dc37d8c" providerId="AD" clId="Web-{014CB68D-C47D-A99A-0993-7C420C81DD4D}" dt="2024-04-11T17:46:27.585" v="4" actId="1076"/>
          <ac:spMkLst>
            <pc:docMk/>
            <pc:sldMk cId="1962860318" sldId="256"/>
            <ac:spMk id="6" creationId="{2D2F0FB3-0C29-FA3C-A54E-0F8C6FDB9378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2F94D7A-D7FF-B440-B861-D2AD58297BDC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B54F986-318C-6E43-9943-C174EC4347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11690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 defTabSz="685800">
              <a:defRPr/>
            </a:pPr>
            <a:r>
              <a:rPr lang="en-US" sz="1200" b="1" kern="50" spc="-15" smtClean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3</a:t>
            </a:r>
            <a:r>
              <a:rPr lang="en-US" sz="1200" b="1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ocalization of claudin-5 protein in hiPSC-derived BMECs co-cultured with RBCs or </a:t>
            </a:r>
            <a:r>
              <a:rPr lang="en-US" sz="1200" b="1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f-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RBCs at 6-hours post co-culture</a:t>
            </a:r>
            <a:r>
              <a:rPr lang="en-US" sz="1200" b="1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US" sz="12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laudin-5 localization in hiPSC-derived BMECs co-cultured with RBCs and </a:t>
            </a:r>
            <a:r>
              <a:rPr lang="en-US" sz="1200" i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f-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RBCs. </a:t>
            </a:r>
            <a:r>
              <a:rPr lang="en-US" sz="12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mmunofluorescent images are shown with claudin-5 in green. </a:t>
            </a:r>
            <a:r>
              <a:rPr lang="en-US" sz="1200" b="1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B)</a:t>
            </a:r>
            <a:r>
              <a:rPr lang="en-US" sz="1200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Quantification of discontinuous tight junctions for claudin-5, using area fraction index (%). Values are normalized to hiPSC-derived BMECs only and presented as mean +/- SEM of three replicates from a single differentiation and experiments were repeated in two independent rounds of iPSC-derived BMEC differentiation. *</a:t>
            </a:r>
            <a:r>
              <a:rPr lang="en-US" sz="1200" i="1" kern="50" spc="-15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&lt;0.05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B54F986-318C-6E43-9943-C174EC434784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159536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BA2ED44D-6AA4-3281-BB83-D6DAF8ED8E2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xmlns="" id="{6C59F5DF-3FE1-3DCF-455F-EC246C8569A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E3FFF989-2A32-7E9D-6A86-35E66C0D68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9C5D5A-B6BD-C944-8F68-DA67F2A419AD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89884560-7331-321B-AF8D-1028641076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9EA6FDB8-CC91-726C-6925-99ACC2C603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B69CAA-6775-2C45-BCE4-3AEB16DBCD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91553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070AF584-2C34-A36D-5B98-27E53819EE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A0638A37-9821-3621-30B2-4644C9F7539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E49DC442-9C6B-CFF4-EA03-04288CEBA8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9C5D5A-B6BD-C944-8F68-DA67F2A419AD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2517F77A-46CF-5FA1-C48C-C582FC121A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AC5631BC-3187-0485-00F7-BB41F3A4AD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B69CAA-6775-2C45-BCE4-3AEB16DBCD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87600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xmlns="" id="{756103A0-8C26-8D9E-7685-09F7E5095E9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xmlns="" id="{F4CC21EE-84D3-38E3-7A8A-A9F208EBB08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F3CE6286-E511-D3C4-BA86-EE3C277EAE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9C5D5A-B6BD-C944-8F68-DA67F2A419AD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3C8DB44D-9DCA-A119-6924-52095B82ED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757DA795-DDCA-0605-77D0-93EA77B2EC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B69CAA-6775-2C45-BCE4-3AEB16DBCD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14009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2491DF54-6835-D6AE-66A3-C571CB3003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6305B45F-7D3F-69AF-6ABA-BB4B14FEEB0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7D41CF59-0975-DC15-29F2-51FA330EEF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9C5D5A-B6BD-C944-8F68-DA67F2A419AD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957D721E-EF90-73EA-D8F0-0ADBC4BF27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B1213FA2-4B6B-223A-4702-868CFB9931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B69CAA-6775-2C45-BCE4-3AEB16DBCD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19414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3227E53C-0A65-29AA-9396-D91CA7034F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97D8F8BC-C14D-0DC1-5E19-C529DEC9CE1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A73984D6-B7D0-6D0A-9878-7CB3808027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9C5D5A-B6BD-C944-8F68-DA67F2A419AD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B740064B-01AE-21E0-4C45-49CDFC7BB0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8A045FD7-05BB-5C73-F4C8-D66C30FED0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B69CAA-6775-2C45-BCE4-3AEB16DBCD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5599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DEEBE41-9BC2-AEFD-4661-049B692D51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B6B4EBA5-2081-75AB-2E5A-94A20227C75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51FBC242-0568-3FAB-6635-9FD15B9666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367D6909-50A9-4E92-AF97-F503DEA197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9C5D5A-B6BD-C944-8F68-DA67F2A419AD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98AEE6DD-557D-3750-63BC-BC2ABF00BA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FC5A2074-9552-D64E-2274-90C57A36D2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B69CAA-6775-2C45-BCE4-3AEB16DBCD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98224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530B83CC-217C-0E28-152B-7669E2612A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81DF19E4-EA05-A411-C58E-2368296AC2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xmlns="" id="{ACDC47D0-05C3-F1E6-6A1F-926CB99926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xmlns="" id="{AFA34282-D4DF-FE44-F80A-45ECC5ABBE8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xmlns="" id="{28DDD2EF-C612-79A6-E7D3-323CE1F24B7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xmlns="" id="{32B24E71-0DA9-9758-7A28-46F349FE51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9C5D5A-B6BD-C944-8F68-DA67F2A419AD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xmlns="" id="{011D99D7-EE2D-BC49-6C7A-41197D4944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xmlns="" id="{85205FA1-19A9-5853-79F5-CCA1A8356B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B69CAA-6775-2C45-BCE4-3AEB16DBCD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46856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D319E068-6F34-74E7-C593-1CBA896569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xmlns="" id="{7A8C6BA0-63F9-1B1C-CDD6-02BDC03F54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9C5D5A-B6BD-C944-8F68-DA67F2A419AD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xmlns="" id="{3067DE0A-0C50-333B-8D55-7D153AC204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xmlns="" id="{95DBCF47-8B3D-D673-E702-53E520DC1D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B69CAA-6775-2C45-BCE4-3AEB16DBCD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16025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xmlns="" id="{D8611693-4FAA-EB1F-4DC9-7C09F9AB3C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9C5D5A-B6BD-C944-8F68-DA67F2A419AD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xmlns="" id="{C263AFB7-7158-E007-3DC7-F0846EF960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xmlns="" id="{93187E3A-234E-C035-9C72-EF35F80E17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B69CAA-6775-2C45-BCE4-3AEB16DBCD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29825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F63DC6FC-7F99-3081-7975-F667389636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xmlns="" id="{200A8518-296F-DC56-D8A3-7196AC30F36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EFF9E42D-F84A-A58A-942B-5C08856F76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9876FDE5-2C6E-74A7-2F74-961976EFA6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9C5D5A-B6BD-C944-8F68-DA67F2A419AD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57631909-6AB4-33B6-808F-3512883CF7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C7BA3C04-CED2-3CC9-FBCA-803AA17315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B69CAA-6775-2C45-BCE4-3AEB16DBCD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12495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xmlns="" id="{E69991B6-81E2-F746-09A3-C0A529C652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xmlns="" id="{027608A6-755F-EA63-5FD5-F855B245550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xmlns="" id="{97A9C872-80B8-2B4B-FD89-07CCE9C4E09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xmlns="" id="{FBEE025D-D30C-92D4-6161-BE2D8566C7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9C5D5A-B6BD-C944-8F68-DA67F2A419AD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xmlns="" id="{EA852C1E-82B1-84AC-756E-7B8CA02696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xmlns="" id="{407DCA94-087D-EB23-25D2-D4FA7986DE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B69CAA-6775-2C45-BCE4-3AEB16DBCD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46023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xmlns="" id="{05F373B9-F09F-21EA-1545-E1FE74FB47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xmlns="" id="{5F6320A5-B10F-3E4A-1BCF-B813DCA06A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xmlns="" id="{BD322457-B9D7-D3B3-4CF8-31636EC2FD0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D9C5D5A-B6BD-C944-8F68-DA67F2A419AD}" type="datetimeFigureOut">
              <a:rPr lang="en-US" smtClean="0"/>
              <a:t>4/20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xmlns="" id="{B5B80A90-5467-DA0F-5C2D-41B00385158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xmlns="" id="{0DAAEA16-3CA3-753B-14CC-C60431383A1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2B69CAA-6775-2C45-BCE4-3AEB16DBCD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46415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Several images of cells&#10;&#10;Description automatically generated">
            <a:extLst>
              <a:ext uri="{FF2B5EF4-FFF2-40B4-BE49-F238E27FC236}">
                <a16:creationId xmlns:a16="http://schemas.microsoft.com/office/drawing/2014/main" xmlns="" id="{85602DE0-5691-BA81-8839-33FB2E50BB1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00250" y="407276"/>
            <a:ext cx="8191500" cy="409575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2D2F0FB3-0C29-FA3C-A54E-0F8C6FDB9378}"/>
              </a:ext>
            </a:extLst>
          </p:cNvPr>
          <p:cNvSpPr txBox="1"/>
          <p:nvPr/>
        </p:nvSpPr>
        <p:spPr>
          <a:xfrm>
            <a:off x="1642772" y="4602010"/>
            <a:ext cx="8058699" cy="861774"/>
          </a:xfrm>
          <a:prstGeom prst="rect">
            <a:avLst/>
          </a:prstGeom>
          <a:noFill/>
        </p:spPr>
        <p:txBody>
          <a:bodyPr wrap="square" lIns="91440" tIns="45720" rIns="91440" bIns="45720" anchor="t">
            <a:spAutoFit/>
          </a:bodyPr>
          <a:lstStyle/>
          <a:p>
            <a:pPr algn="just" defTabSz="685800">
              <a:defRPr/>
            </a:pPr>
            <a:r>
              <a:rPr lang="en-US" sz="1000" b="1" kern="50" spc="-15" dirty="0" smtClean="0">
                <a:solidFill>
                  <a:srgbClr val="000000"/>
                </a:solidFill>
                <a:latin typeface="Times New Roman"/>
                <a:ea typeface="Calibri" panose="020F0502020204030204" pitchFamily="34" charset="0"/>
                <a:cs typeface="Times New Roman"/>
              </a:rPr>
              <a:t>Figure S3</a:t>
            </a:r>
            <a:r>
              <a:rPr lang="en-US" sz="1000" b="1" kern="50" spc="-15" dirty="0">
                <a:solidFill>
                  <a:srgbClr val="000000"/>
                </a:solidFill>
                <a:latin typeface="Times New Roman"/>
                <a:ea typeface="Calibri" panose="020F0502020204030204" pitchFamily="34" charset="0"/>
                <a:cs typeface="Times New Roman"/>
              </a:rPr>
              <a:t>. </a:t>
            </a:r>
            <a:r>
              <a:rPr lang="en-US" sz="1000" b="1" dirty="0">
                <a:latin typeface="Times New Roman"/>
                <a:ea typeface="Calibri" panose="020F0502020204030204" pitchFamily="34" charset="0"/>
                <a:cs typeface="Times New Roman"/>
              </a:rPr>
              <a:t>Localization of claudin-5 protein in hiPSC-derived BMECs co-cultured with RBCs or </a:t>
            </a:r>
            <a:r>
              <a:rPr lang="en-US" sz="1000" b="1" i="1" dirty="0">
                <a:latin typeface="Times New Roman"/>
                <a:ea typeface="Calibri" panose="020F0502020204030204" pitchFamily="34" charset="0"/>
                <a:cs typeface="Times New Roman"/>
              </a:rPr>
              <a:t>Pf-</a:t>
            </a:r>
            <a:r>
              <a:rPr lang="en-US" sz="1000" b="1" dirty="0">
                <a:latin typeface="Times New Roman"/>
                <a:ea typeface="Calibri" panose="020F0502020204030204" pitchFamily="34" charset="0"/>
                <a:cs typeface="Times New Roman"/>
              </a:rPr>
              <a:t>iRBCs at 6-hours post co-culture</a:t>
            </a:r>
            <a:r>
              <a:rPr lang="en-US" sz="1000" b="1" kern="50" spc="-15" dirty="0">
                <a:solidFill>
                  <a:srgbClr val="000000"/>
                </a:solidFill>
                <a:latin typeface="Times New Roman"/>
                <a:ea typeface="Calibri" panose="020F0502020204030204" pitchFamily="34" charset="0"/>
                <a:cs typeface="Times New Roman"/>
              </a:rPr>
              <a:t>.</a:t>
            </a:r>
            <a:r>
              <a:rPr lang="en-US" sz="1000" kern="50" spc="-15" dirty="0">
                <a:solidFill>
                  <a:srgbClr val="000000"/>
                </a:solidFill>
                <a:latin typeface="Times New Roman"/>
                <a:ea typeface="Calibri" panose="020F0502020204030204" pitchFamily="34" charset="0"/>
                <a:cs typeface="Times New Roman"/>
              </a:rPr>
              <a:t> </a:t>
            </a:r>
            <a:r>
              <a:rPr lang="en-US" sz="1000" b="1" dirty="0">
                <a:latin typeface="Times New Roman"/>
                <a:ea typeface="Calibri" panose="020F0502020204030204" pitchFamily="34" charset="0"/>
                <a:cs typeface="Times New Roman"/>
              </a:rPr>
              <a:t>(A) </a:t>
            </a:r>
            <a:r>
              <a:rPr lang="en-US" sz="1000" dirty="0">
                <a:latin typeface="Times New Roman"/>
                <a:ea typeface="Calibri" panose="020F0502020204030204" pitchFamily="34" charset="0"/>
                <a:cs typeface="Times New Roman"/>
              </a:rPr>
              <a:t>Claudin-5 localization in hiPSC-derived BMECs co-cultured with RBCs and </a:t>
            </a:r>
            <a:r>
              <a:rPr lang="en-US" sz="1000" i="1" dirty="0" err="1">
                <a:latin typeface="Times New Roman"/>
                <a:ea typeface="Calibri" panose="020F0502020204030204" pitchFamily="34" charset="0"/>
                <a:cs typeface="Times New Roman"/>
              </a:rPr>
              <a:t>Pf-</a:t>
            </a:r>
            <a:r>
              <a:rPr lang="en-US" sz="1000" dirty="0" err="1">
                <a:latin typeface="Times New Roman"/>
                <a:ea typeface="Calibri" panose="020F0502020204030204" pitchFamily="34" charset="0"/>
                <a:cs typeface="Times New Roman"/>
              </a:rPr>
              <a:t>iRBCs</a:t>
            </a:r>
            <a:r>
              <a:rPr lang="en-US" sz="1000" dirty="0">
                <a:latin typeface="Times New Roman"/>
                <a:ea typeface="Calibri" panose="020F0502020204030204" pitchFamily="34" charset="0"/>
                <a:cs typeface="Times New Roman"/>
              </a:rPr>
              <a:t>. </a:t>
            </a:r>
            <a:r>
              <a:rPr lang="en-US" sz="1000" dirty="0">
                <a:solidFill>
                  <a:srgbClr val="000000"/>
                </a:solidFill>
                <a:latin typeface="Times New Roman"/>
                <a:ea typeface="Calibri" panose="020F0502020204030204" pitchFamily="34" charset="0"/>
                <a:cs typeface="Times New Roman"/>
              </a:rPr>
              <a:t>Red boxes indicate breaks observed in TJ localization (digital expansion zoomed in on breaks in localization). </a:t>
            </a:r>
            <a:r>
              <a:rPr lang="en-US" sz="1000" kern="50" spc="-15" dirty="0">
                <a:solidFill>
                  <a:srgbClr val="000000"/>
                </a:solidFill>
                <a:latin typeface="Times New Roman"/>
                <a:ea typeface="Calibri" panose="020F0502020204030204" pitchFamily="34" charset="0"/>
                <a:cs typeface="Times New Roman"/>
              </a:rPr>
              <a:t>Immunofluorescent images are shown with claudin-5 in green. </a:t>
            </a:r>
            <a:r>
              <a:rPr lang="en-US" sz="1000" b="1" kern="50" spc="-15" dirty="0">
                <a:solidFill>
                  <a:srgbClr val="000000"/>
                </a:solidFill>
                <a:latin typeface="Times New Roman"/>
                <a:ea typeface="Calibri" panose="020F0502020204030204" pitchFamily="34" charset="0"/>
                <a:cs typeface="Times New Roman"/>
              </a:rPr>
              <a:t>(B)</a:t>
            </a:r>
            <a:r>
              <a:rPr lang="en-US" sz="1000" kern="50" spc="-15" dirty="0">
                <a:solidFill>
                  <a:srgbClr val="000000"/>
                </a:solidFill>
                <a:latin typeface="Times New Roman"/>
                <a:ea typeface="Calibri" panose="020F0502020204030204" pitchFamily="34" charset="0"/>
                <a:cs typeface="Times New Roman"/>
              </a:rPr>
              <a:t> Quantification of discontinuous tight junctions for claudin-5, using area fraction index (%). Values are normalized to hiPSC-derived BMECs only and presented as mean +/- SEM of three replicates from a single differentiation and experiments were repeated in two independent rounds of iPSC-derived BMEC differentiation. *</a:t>
            </a:r>
            <a:r>
              <a:rPr lang="en-US" sz="1000" i="1" kern="50" spc="-15" dirty="0">
                <a:solidFill>
                  <a:srgbClr val="000000"/>
                </a:solidFill>
                <a:latin typeface="Times New Roman"/>
                <a:ea typeface="Calibri" panose="020F0502020204030204" pitchFamily="34" charset="0"/>
                <a:cs typeface="Times New Roman"/>
              </a:rPr>
              <a:t>P&lt;0.05.</a:t>
            </a:r>
            <a:endParaRPr lang="en-US" sz="10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9628603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46F83623FE0101439BF9CBCA708448C2" ma:contentTypeVersion="14" ma:contentTypeDescription="Create a new document." ma:contentTypeScope="" ma:versionID="43435aca2c006b86cb5a1b4b69da5887">
  <xsd:schema xmlns:xsd="http://www.w3.org/2001/XMLSchema" xmlns:xs="http://www.w3.org/2001/XMLSchema" xmlns:p="http://schemas.microsoft.com/office/2006/metadata/properties" xmlns:ns2="88a897e8-d4da-4754-b76c-471f0d488363" xmlns:ns3="9a2030ed-2c9c-4ecf-96df-48ffd2037682" targetNamespace="http://schemas.microsoft.com/office/2006/metadata/properties" ma:root="true" ma:fieldsID="8e3ea8bdce2d7a53ced3a228efd8bbf6" ns2:_="" ns3:_="">
    <xsd:import namespace="88a897e8-d4da-4754-b76c-471f0d488363"/>
    <xsd:import namespace="9a2030ed-2c9c-4ecf-96df-48ffd2037682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3:SharedWithUsers" minOccurs="0"/>
                <xsd:element ref="ns3:SharedWithDetails" minOccurs="0"/>
                <xsd:element ref="ns2:lcf76f155ced4ddcb4097134ff3c332f" minOccurs="0"/>
                <xsd:element ref="ns3:TaxCatchAll" minOccurs="0"/>
                <xsd:element ref="ns2:MediaServiceObjectDetectorVersion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ServiceSearchProperties" minOccurs="0"/>
                <xsd:element ref="ns2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8a897e8-d4da-4754-b76c-471f0d488363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lcf76f155ced4ddcb4097134ff3c332f" ma:index="13" nillable="true" ma:taxonomy="true" ma:internalName="lcf76f155ced4ddcb4097134ff3c332f" ma:taxonomyFieldName="MediaServiceImageTags" ma:displayName="Image Tags" ma:readOnly="false" ma:fieldId="{5cf76f15-5ced-4ddc-b409-7134ff3c332f}" ma:taxonomyMulti="true" ma:sspId="0eec0a79-46cb-4568-9b1b-2d720bd3207c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15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OCR" ma:index="16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7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8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9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SearchProperties" ma:index="20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Location" ma:index="21" nillable="true" ma:displayName="Location" ma:indexed="true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a2030ed-2c9c-4ecf-96df-48ffd2037682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4" nillable="true" ma:displayName="Taxonomy Catch All Column" ma:hidden="true" ma:list="{d587f133-08ee-41ab-81b8-7455cffb4ef8}" ma:internalName="TaxCatchAll" ma:showField="CatchAllData" ma:web="9a2030ed-2c9c-4ecf-96df-48ffd2037682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88a897e8-d4da-4754-b76c-471f0d488363">
      <Terms xmlns="http://schemas.microsoft.com/office/infopath/2007/PartnerControls"/>
    </lcf76f155ced4ddcb4097134ff3c332f>
    <TaxCatchAll xmlns="9a2030ed-2c9c-4ecf-96df-48ffd2037682" xsi:nil="true"/>
  </documentManagement>
</p:properties>
</file>

<file path=customXml/itemProps1.xml><?xml version="1.0" encoding="utf-8"?>
<ds:datastoreItem xmlns:ds="http://schemas.openxmlformats.org/officeDocument/2006/customXml" ds:itemID="{F95FF746-BB61-476F-8230-51F32FB88B99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88a897e8-d4da-4754-b76c-471f0d488363"/>
    <ds:schemaRef ds:uri="9a2030ed-2c9c-4ecf-96df-48ffd2037682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362FF2BA-C870-4BE0-992F-83A46CC40EB0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3623CDBE-C3A8-4D38-825F-E38701D081C2}">
  <ds:schemaRefs>
    <ds:schemaRef ds:uri="http://schemas.microsoft.com/office/2006/metadata/properties"/>
    <ds:schemaRef ds:uri="http://schemas.microsoft.com/office/infopath/2007/PartnerControls"/>
    <ds:schemaRef ds:uri="88a897e8-d4da-4754-b76c-471f0d488363"/>
    <ds:schemaRef ds:uri="9a2030ed-2c9c-4ecf-96df-48ffd2037682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9</Words>
  <Application>Microsoft Office PowerPoint</Application>
  <PresentationFormat>Widescreen</PresentationFormat>
  <Paragraphs>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opinadhan, Adnan</dc:creator>
  <cp:lastModifiedBy>Maria Flora V.</cp:lastModifiedBy>
  <cp:revision>13</cp:revision>
  <dcterms:created xsi:type="dcterms:W3CDTF">2024-04-11T16:53:19Z</dcterms:created>
  <dcterms:modified xsi:type="dcterms:W3CDTF">2024-04-20T11:58:1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46F83623FE0101439BF9CBCA708448C2</vt:lpwstr>
  </property>
  <property fmtid="{D5CDD505-2E9C-101B-9397-08002B2CF9AE}" pid="3" name="MediaServiceImageTags">
    <vt:lpwstr/>
  </property>
</Properties>
</file>